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318" r:id="rId3"/>
    <p:sldId id="300" r:id="rId4"/>
    <p:sldId id="302" r:id="rId5"/>
    <p:sldId id="304" r:id="rId6"/>
    <p:sldId id="306" r:id="rId7"/>
    <p:sldId id="308" r:id="rId8"/>
    <p:sldId id="310" r:id="rId9"/>
    <p:sldId id="314" r:id="rId10"/>
    <p:sldId id="315" r:id="rId11"/>
    <p:sldId id="316" r:id="rId12"/>
    <p:sldId id="317" r:id="rId13"/>
    <p:sldId id="319" r:id="rId14"/>
    <p:sldId id="320" r:id="rId1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7" d="100"/>
          <a:sy n="77" d="100"/>
        </p:scale>
        <p:origin x="806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D70BBC-B7D5-42E0-93C2-2C5314E2354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64E7EEE-EDFC-4E0B-BD1F-CF8210A9E8A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707264-60FD-4786-A969-632E22D7B2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C6B5A-9B3A-4059-8B48-F0839FA3F616}" type="datetimeFigureOut">
              <a:rPr lang="en-GB" smtClean="0"/>
              <a:t>21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67A9C4-B27D-453B-B8D0-6F1CC4D2AF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18AC20-632A-4DA5-A902-5689AE6B2F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4574F-E7BE-4C8A-8F33-021ADD1E16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85972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34B0EA-EDE6-46F4-AA69-E935B090D5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76BC9F9-553D-4376-ABDA-77AEBB9766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00557C-C0E2-4F81-B4E3-307A7BD652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C6B5A-9B3A-4059-8B48-F0839FA3F616}" type="datetimeFigureOut">
              <a:rPr lang="en-GB" smtClean="0"/>
              <a:t>21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658339-830D-4E43-A1E3-CE28545B34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820B89-8E18-47E4-B57F-169AC9CAE1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4574F-E7BE-4C8A-8F33-021ADD1E16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68588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35BC06D-D4A1-4307-8513-A101CEADFFE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7C02ADA-2208-482C-BE24-905FDAB3D5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2B53F3-AC42-4FF6-8ACD-E2A9746415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C6B5A-9B3A-4059-8B48-F0839FA3F616}" type="datetimeFigureOut">
              <a:rPr lang="en-GB" smtClean="0"/>
              <a:t>21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6C9B68-D955-4819-8163-0F1B6D8725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B7C47F-538C-4D89-B5B3-4AC2A26A4C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4574F-E7BE-4C8A-8F33-021ADD1E16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51692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B9BCD0-EF4A-4FCE-AB9B-47E25FE1FA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EBC0539-2D52-4404-893E-31E05237C56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41C7D8-BB30-4772-9C29-34E7179F79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C6B5A-9B3A-4059-8B48-F0839FA3F616}" type="datetimeFigureOut">
              <a:rPr lang="en-GB" smtClean="0"/>
              <a:t>21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23DB74-AB92-426C-AFE0-A166EA0A13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8AEE72-3912-4B3F-936E-CA584213A3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4574F-E7BE-4C8A-8F33-021ADD1E16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82813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3F5E9E-7331-4F39-8033-CA00863996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380EB90-99E9-4AB4-8335-4F21587475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0FB99A-06F2-40FA-A586-1BAB7FF104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C6B5A-9B3A-4059-8B48-F0839FA3F616}" type="datetimeFigureOut">
              <a:rPr lang="en-GB" smtClean="0"/>
              <a:t>21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AA54FC-5247-4CC9-8842-2CC0EA6655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4B337C-6C2C-411B-BEA4-74ED754080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4574F-E7BE-4C8A-8F33-021ADD1E16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29712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AD3FA6-C4BE-4D6A-AE27-609C230399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6E326DB-B26B-4016-A241-38A5AC94D83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89DF3DE-42A9-488B-845B-83477957D8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BFB1FF-7026-4304-9FBA-6F9F0F6A72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C6B5A-9B3A-4059-8B48-F0839FA3F616}" type="datetimeFigureOut">
              <a:rPr lang="en-GB" smtClean="0"/>
              <a:t>21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C05C894-9902-49E4-92F3-E4E93FB5AA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E419BD3-77CA-4CE3-B396-AB7FE33C50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4574F-E7BE-4C8A-8F33-021ADD1E16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46078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003D16-D174-4351-9D48-149B317A92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8A514B1-4854-45C9-B060-0DBEAA040C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557BE70-A91A-4CDB-8C9D-B155F72560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61DF0AD-504B-4054-8B35-8BF9350DFF2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81B8FAE-159C-4824-AA15-C8FCA579E0F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6877D35-06DB-4428-B8E0-5F55A4DAC1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C6B5A-9B3A-4059-8B48-F0839FA3F616}" type="datetimeFigureOut">
              <a:rPr lang="en-GB" smtClean="0"/>
              <a:t>21/05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BF2FE04-0FDB-434B-8388-AE179FFDDB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C896E1B-04DA-4E97-A8DE-A035D13682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4574F-E7BE-4C8A-8F33-021ADD1E16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9736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08E99E-2C78-4CCB-9641-0C98CABD4D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9993DBA-3C68-4B94-80ED-7AB91DAC8F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C6B5A-9B3A-4059-8B48-F0839FA3F616}" type="datetimeFigureOut">
              <a:rPr lang="en-GB" smtClean="0"/>
              <a:t>21/05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76AC6AD-BA0E-453B-BD88-1BA3B419BD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564B53C-8E6E-40BF-8876-E2D5FC4A32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4574F-E7BE-4C8A-8F33-021ADD1E16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47500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2F8CA42-068E-4314-845A-E6DF0BF445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C6B5A-9B3A-4059-8B48-F0839FA3F616}" type="datetimeFigureOut">
              <a:rPr lang="en-GB" smtClean="0"/>
              <a:t>21/05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DDD70BC-AC91-4889-AA11-7AD58D5847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E8AFA1D-AB14-4253-8A52-D7AFF28B8D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4574F-E7BE-4C8A-8F33-021ADD1E16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10624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403B4F-C34B-491C-8628-348058C811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860AB41-B878-49C7-A64E-26E10D0B6C5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2D91C9E-B28F-4426-905A-EBF4883D72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F334701-6CA0-4F38-AD4B-89A530FF54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C6B5A-9B3A-4059-8B48-F0839FA3F616}" type="datetimeFigureOut">
              <a:rPr lang="en-GB" smtClean="0"/>
              <a:t>21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D0CEAD-C7BC-40A6-A9E7-E897FF1F80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B3F8E66-5A61-4AD7-811D-05CC5B43EC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4574F-E7BE-4C8A-8F33-021ADD1E16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82159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2BBD56-DCA6-4B07-8880-7CC9147CE1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A22E98E-1FF7-4F1F-A52C-B275FBC7FB2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FB4DF19-4CCF-4F23-ABF8-C2D5E17946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A6ADE95-89FD-46EC-8118-002F7FAE2B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C6B5A-9B3A-4059-8B48-F0839FA3F616}" type="datetimeFigureOut">
              <a:rPr lang="en-GB" smtClean="0"/>
              <a:t>21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69FE94-46CE-400C-8F81-86F45E5A71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947C35-A0FF-4014-9A32-481BB59D03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B4574F-E7BE-4C8A-8F33-021ADD1E16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68273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B108459-A631-4E77-B25F-798FA48FBC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060EDEB-94A8-46F7-842F-F9F785C7AE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37AABC-29E3-4968-91E1-E9D37242870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2C6B5A-9B3A-4059-8B48-F0839FA3F616}" type="datetimeFigureOut">
              <a:rPr lang="en-GB" smtClean="0"/>
              <a:t>21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65747B-F366-44F6-A980-566959E38FB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489470-4004-4B78-B597-D35CAAA9D63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B4574F-E7BE-4C8A-8F33-021ADD1E16F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00187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blpatil2046@gmail.com" TargetMode="Externa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package" Target="../embeddings/Microsoft_Excel_Worksheet.xlsx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package" Target="../embeddings/Microsoft_Excel_Worksheet1.xlsx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5.emf"/><Relationship Id="rId4" Type="http://schemas.openxmlformats.org/officeDocument/2006/relationships/package" Target="../embeddings/Microsoft_Excel_Worksheet2.xlsx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0DF3E2-6EB7-4764-A186-3E43AEB75C8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715617"/>
            <a:ext cx="9144000" cy="785192"/>
          </a:xfrm>
        </p:spPr>
        <p:txBody>
          <a:bodyPr>
            <a:normAutofit fontScale="90000"/>
          </a:bodyPr>
          <a:lstStyle/>
          <a:p>
            <a:r>
              <a:rPr lang="en-GB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+mn-lt"/>
              </a:rPr>
              <a:t>Supplementary Figure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BCB67B9-333F-46F3-8B3B-7D379BC2933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665922" y="1974953"/>
            <a:ext cx="11012556" cy="3640655"/>
          </a:xfrm>
        </p:spPr>
        <p:txBody>
          <a:bodyPr>
            <a:noAutofit/>
          </a:bodyPr>
          <a:lstStyle/>
          <a:p>
            <a:pPr algn="just">
              <a:lnSpc>
                <a:spcPct val="150000"/>
              </a:lnSpc>
              <a:spcAft>
                <a:spcPts val="600"/>
              </a:spcAft>
            </a:pPr>
            <a:r>
              <a:rPr lang="en-GB" b="1" dirty="0">
                <a:effectLst/>
                <a:ea typeface="Times New Roman" panose="02020603050405020304" pitchFamily="18" charset="0"/>
              </a:rPr>
              <a:t>Differential expression of microRNAs in response to </a:t>
            </a:r>
            <a:r>
              <a:rPr lang="en-GB" b="1" i="1" dirty="0">
                <a:effectLst/>
                <a:ea typeface="Times New Roman" panose="02020603050405020304" pitchFamily="18" charset="0"/>
              </a:rPr>
              <a:t>Papaya ringspot virus</a:t>
            </a:r>
            <a:r>
              <a:rPr lang="en-GB" b="1" dirty="0">
                <a:effectLst/>
                <a:ea typeface="Times New Roman" panose="02020603050405020304" pitchFamily="18" charset="0"/>
              </a:rPr>
              <a:t> infection in differentially responding genotypes of Papaya (</a:t>
            </a:r>
            <a:r>
              <a:rPr lang="en-GB" b="1" i="1" dirty="0" err="1">
                <a:effectLst/>
                <a:ea typeface="Times New Roman" panose="02020603050405020304" pitchFamily="18" charset="0"/>
              </a:rPr>
              <a:t>Carica</a:t>
            </a:r>
            <a:r>
              <a:rPr lang="en-GB" b="1" i="1" dirty="0">
                <a:effectLst/>
                <a:ea typeface="Times New Roman" panose="02020603050405020304" pitchFamily="18" charset="0"/>
              </a:rPr>
              <a:t> papaya</a:t>
            </a:r>
            <a:r>
              <a:rPr lang="en-GB" b="1" dirty="0">
                <a:effectLst/>
                <a:ea typeface="Times New Roman" panose="02020603050405020304" pitchFamily="18" charset="0"/>
              </a:rPr>
              <a:t> L.) and its wild relative</a:t>
            </a:r>
            <a:endParaRPr lang="en-IN" dirty="0">
              <a:effectLst/>
              <a:ea typeface="Calibri" panose="020F0502020204030204" pitchFamily="34" charset="0"/>
            </a:endParaRPr>
          </a:p>
          <a:p>
            <a:pPr marL="115570" indent="-115570" algn="just">
              <a:lnSpc>
                <a:spcPct val="150000"/>
              </a:lnSpc>
              <a:spcAft>
                <a:spcPts val="60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Basavaprabhu L. Patil</a:t>
            </a:r>
            <a:r>
              <a:rPr lang="en-US" sz="1800" baseline="300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1*</a:t>
            </a:r>
            <a:r>
              <a:rPr lang="en-US" sz="18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 and </a:t>
            </a:r>
            <a:r>
              <a:rPr lang="en-US" sz="1800" dirty="0" err="1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Savarni</a:t>
            </a:r>
            <a:r>
              <a:rPr lang="en-US" sz="18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 Tripathi</a:t>
            </a:r>
            <a:r>
              <a:rPr lang="en-US" sz="1800" baseline="300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2</a:t>
            </a:r>
            <a:endParaRPr lang="en-IN" sz="1800" dirty="0">
              <a:effectLst/>
              <a:ea typeface="Calibri" panose="020F0502020204030204" pitchFamily="34" charset="0"/>
            </a:endParaRPr>
          </a:p>
          <a:p>
            <a:pPr marL="115570" indent="-115570" algn="just">
              <a:lnSpc>
                <a:spcPct val="150000"/>
              </a:lnSpc>
              <a:spcAft>
                <a:spcPts val="600"/>
              </a:spcAft>
            </a:pPr>
            <a:r>
              <a:rPr lang="en-US" sz="1800" baseline="300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1</a:t>
            </a:r>
            <a:r>
              <a:rPr lang="en-US" sz="18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ICAR-Indian Institute of Horticultural Research, Bengaluru-560089, India</a:t>
            </a:r>
            <a:endParaRPr lang="en-IN" sz="1800" dirty="0">
              <a:effectLst/>
              <a:ea typeface="Calibri" panose="020F0502020204030204" pitchFamily="34" charset="0"/>
            </a:endParaRPr>
          </a:p>
          <a:p>
            <a:pPr algn="just">
              <a:lnSpc>
                <a:spcPct val="150000"/>
              </a:lnSpc>
              <a:spcAft>
                <a:spcPts val="600"/>
              </a:spcAft>
            </a:pPr>
            <a:r>
              <a:rPr lang="en-GB" sz="1800" baseline="300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2</a:t>
            </a:r>
            <a:r>
              <a:rPr lang="en-GB" sz="18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ICAR-Indian Agricultural Research Institute, Regional Station, Pune-411067, India</a:t>
            </a:r>
            <a:r>
              <a:rPr lang="en-GB" sz="1800" baseline="300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 </a:t>
            </a:r>
            <a:endParaRPr lang="en-IN" sz="1800" dirty="0">
              <a:effectLst/>
              <a:ea typeface="Calibri" panose="020F0502020204030204" pitchFamily="34" charset="0"/>
            </a:endParaRPr>
          </a:p>
          <a:p>
            <a:pPr algn="just">
              <a:lnSpc>
                <a:spcPct val="150000"/>
              </a:lnSpc>
              <a:spcAft>
                <a:spcPts val="600"/>
              </a:spcAft>
            </a:pPr>
            <a:r>
              <a:rPr lang="en-GB" sz="1800" baseline="300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*</a:t>
            </a:r>
            <a:r>
              <a:rPr lang="en-GB" sz="18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Corresponding author E-mail: </a:t>
            </a:r>
            <a:r>
              <a:rPr lang="en-GB" sz="1800" u="sng" dirty="0">
                <a:solidFill>
                  <a:srgbClr val="0000FF"/>
                </a:solidFill>
                <a:effectLst/>
                <a:ea typeface="Times New Roman" panose="02020603050405020304" pitchFamily="18" charset="0"/>
                <a:hlinkClick r:id="rId2"/>
              </a:rPr>
              <a:t>blpatil2046@gmail.com</a:t>
            </a:r>
            <a:r>
              <a:rPr lang="en-GB" sz="1800" u="sng" dirty="0">
                <a:solidFill>
                  <a:srgbClr val="0000FF"/>
                </a:solidFill>
                <a:effectLst/>
                <a:ea typeface="Times New Roman" panose="02020603050405020304" pitchFamily="18" charset="0"/>
              </a:rPr>
              <a:t>, Basavaprabhu.Patil@icar.gov.in</a:t>
            </a:r>
            <a:r>
              <a:rPr lang="en-GB" sz="18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 </a:t>
            </a:r>
            <a:endParaRPr lang="en-IN" sz="1800" dirty="0">
              <a:effectLst/>
              <a:ea typeface="Calibri" panose="020F0502020204030204" pitchFamily="34" charset="0"/>
            </a:endParaRPr>
          </a:p>
          <a:p>
            <a:endParaRPr lang="en-GB" sz="1800" dirty="0"/>
          </a:p>
        </p:txBody>
      </p:sp>
    </p:spTree>
    <p:extLst>
      <p:ext uri="{BB962C8B-B14F-4D97-AF65-F5344CB8AC3E}">
        <p14:creationId xmlns:p14="http://schemas.microsoft.com/office/powerpoint/2010/main" val="359239461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>
            <a:extLst>
              <a:ext uri="{FF2B5EF4-FFF2-40B4-BE49-F238E27FC236}">
                <a16:creationId xmlns:a16="http://schemas.microsoft.com/office/drawing/2014/main" id="{B03BE04D-407E-42C9-B7CC-3EA9664BD18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76600" y="862013"/>
            <a:ext cx="5638800" cy="51339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F51DFA07-FC4E-4969-90E5-359E7A164BC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60" t="27354" r="75722" b="47492"/>
          <a:stretch/>
        </p:blipFill>
        <p:spPr>
          <a:xfrm>
            <a:off x="8259706" y="4285388"/>
            <a:ext cx="3925302" cy="240244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9A5169A-5524-4112-BBAA-624DF2B219C2}"/>
              </a:ext>
            </a:extLst>
          </p:cNvPr>
          <p:cNvSpPr txBox="1"/>
          <p:nvPr/>
        </p:nvSpPr>
        <p:spPr>
          <a:xfrm>
            <a:off x="109068" y="43941"/>
            <a:ext cx="1175717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9: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 of targets downregulated in VC vs PM-H involved in molecular function</a:t>
            </a:r>
          </a:p>
          <a:p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768181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>
            <a:extLst>
              <a:ext uri="{FF2B5EF4-FFF2-40B4-BE49-F238E27FC236}">
                <a16:creationId xmlns:a16="http://schemas.microsoft.com/office/drawing/2014/main" id="{C03FDACB-6431-47F9-AEA6-C63B6DA6E2C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1788" y="0"/>
            <a:ext cx="11528425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FFF38FF2-4A27-4111-B61F-CE609E4BC34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60" t="27354" r="75722" b="47492"/>
          <a:stretch/>
        </p:blipFill>
        <p:spPr>
          <a:xfrm>
            <a:off x="8259706" y="4285388"/>
            <a:ext cx="3925302" cy="240244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0904B0A-D3AF-4AA2-B3C3-FF68311E7CC3}"/>
              </a:ext>
            </a:extLst>
          </p:cNvPr>
          <p:cNvSpPr txBox="1"/>
          <p:nvPr/>
        </p:nvSpPr>
        <p:spPr>
          <a:xfrm>
            <a:off x="109068" y="43941"/>
            <a:ext cx="1175717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0: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 of targets downregulated in VC vs PS3-H </a:t>
            </a:r>
          </a:p>
          <a:p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olved in biological process</a:t>
            </a:r>
          </a:p>
          <a:p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6543554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>
            <a:extLst>
              <a:ext uri="{FF2B5EF4-FFF2-40B4-BE49-F238E27FC236}">
                <a16:creationId xmlns:a16="http://schemas.microsoft.com/office/drawing/2014/main" id="{C621793F-27E6-4654-B569-4998AE68898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76600" y="862013"/>
            <a:ext cx="5638800" cy="51339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FF97688A-D66A-45F4-8EE2-728AFEB5946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60" t="27354" r="75722" b="47492"/>
          <a:stretch/>
        </p:blipFill>
        <p:spPr>
          <a:xfrm>
            <a:off x="8259706" y="4285388"/>
            <a:ext cx="3925302" cy="240244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4EA0D04-47A5-4DAA-A012-0158A7AC5576}"/>
              </a:ext>
            </a:extLst>
          </p:cNvPr>
          <p:cNvSpPr txBox="1"/>
          <p:nvPr/>
        </p:nvSpPr>
        <p:spPr>
          <a:xfrm>
            <a:off x="109068" y="43941"/>
            <a:ext cx="1175717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1: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 of targets downregulated in VC vs PS3-H involved in molecular function</a:t>
            </a:r>
          </a:p>
          <a:p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929883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D21B1021-47CD-9D0F-E749-165F90F43AE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42521510"/>
              </p:ext>
            </p:extLst>
          </p:nvPr>
        </p:nvGraphicFramePr>
        <p:xfrm>
          <a:off x="2246243" y="1507864"/>
          <a:ext cx="7951304" cy="48021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2" imgW="4581398" imgH="2767682" progId="Excel.Sheet.12">
                  <p:embed/>
                </p:oleObj>
              </mc:Choice>
              <mc:Fallback>
                <p:oleObj name="Worksheet" r:id="rId2" imgW="4581398" imgH="2767682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246243" y="1507864"/>
                        <a:ext cx="7951304" cy="48021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0F7BD2F9-3649-D4EB-842E-B99012AB29E8}"/>
              </a:ext>
            </a:extLst>
          </p:cNvPr>
          <p:cNvSpPr txBox="1"/>
          <p:nvPr/>
        </p:nvSpPr>
        <p:spPr>
          <a:xfrm>
            <a:off x="217412" y="411689"/>
            <a:ext cx="1175717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2: T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gets downregulated in PM vs PS3-H involved in molecular function</a:t>
            </a:r>
          </a:p>
          <a:p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6834323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70E08A98-D392-1BBC-F910-A096E6222C7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51380722"/>
              </p:ext>
            </p:extLst>
          </p:nvPr>
        </p:nvGraphicFramePr>
        <p:xfrm>
          <a:off x="4798892" y="1266794"/>
          <a:ext cx="6973318" cy="41897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2" imgW="4581398" imgH="2752541" progId="Excel.Sheet.12">
                  <p:embed/>
                </p:oleObj>
              </mc:Choice>
              <mc:Fallback>
                <p:oleObj name="Worksheet" r:id="rId2" imgW="4581398" imgH="2752541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798892" y="1266794"/>
                        <a:ext cx="6973318" cy="41897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89B63C6B-47A3-7B97-EA7B-4270E8B052D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74424537"/>
              </p:ext>
            </p:extLst>
          </p:nvPr>
        </p:nvGraphicFramePr>
        <p:xfrm>
          <a:off x="220318" y="1375948"/>
          <a:ext cx="4396470" cy="38122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4" imgW="3459409" imgH="2202377" progId="Excel.Sheet.12">
                  <p:embed/>
                </p:oleObj>
              </mc:Choice>
              <mc:Fallback>
                <p:oleObj name="Worksheet" r:id="rId4" imgW="3459409" imgH="2202377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20318" y="1375948"/>
                        <a:ext cx="4396470" cy="38122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E68B6092-E7C4-DA6B-1AE2-66E3E3C97579}"/>
              </a:ext>
            </a:extLst>
          </p:cNvPr>
          <p:cNvSpPr txBox="1"/>
          <p:nvPr/>
        </p:nvSpPr>
        <p:spPr>
          <a:xfrm>
            <a:off x="217412" y="411689"/>
            <a:ext cx="117571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3</a:t>
            </a: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94464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EB1FCE-6E3F-622D-3CC8-9BEDB26D51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21974" y="265733"/>
            <a:ext cx="5738219" cy="2626553"/>
          </a:xfrm>
        </p:spPr>
        <p:txBody>
          <a:bodyPr>
            <a:normAutofit/>
          </a:bodyPr>
          <a:lstStyle/>
          <a:p>
            <a:r>
              <a:rPr lang="en-GB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GB" sz="2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ure 1. </a:t>
            </a:r>
            <a:r>
              <a:rPr lang="en-GB" sz="2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Workflow for the Illumina (</a:t>
            </a:r>
            <a:r>
              <a:rPr lang="en-GB" sz="2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HiSeq</a:t>
            </a:r>
            <a:r>
              <a:rPr lang="en-GB" sz="2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2500 ) next generation sequencing data analysis</a:t>
            </a:r>
            <a:br>
              <a:rPr lang="en-IN" sz="2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</a:br>
            <a:endParaRPr lang="en-IN" sz="28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2E48886-36DA-8774-EEE2-30036D38BE1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31809" y="121920"/>
            <a:ext cx="5420165" cy="661416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0901521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31B7740F-7957-406F-A683-5ED82E671A74}"/>
              </a:ext>
            </a:extLst>
          </p:cNvPr>
          <p:cNvGrpSpPr/>
          <p:nvPr/>
        </p:nvGrpSpPr>
        <p:grpSpPr>
          <a:xfrm>
            <a:off x="81485" y="0"/>
            <a:ext cx="12029029" cy="6858000"/>
            <a:chOff x="81485" y="0"/>
            <a:chExt cx="12029029" cy="6858000"/>
          </a:xfrm>
        </p:grpSpPr>
        <p:pic>
          <p:nvPicPr>
            <p:cNvPr id="1026" name="Picture 2">
              <a:extLst>
                <a:ext uri="{FF2B5EF4-FFF2-40B4-BE49-F238E27FC236}">
                  <a16:creationId xmlns:a16="http://schemas.microsoft.com/office/drawing/2014/main" id="{81FD1B1E-0BB4-4392-B05C-9BF45B4BECAA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8931" y="0"/>
              <a:ext cx="11514137" cy="685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67F6F485-2BD1-41B3-8171-CDDD60D39D97}"/>
                </a:ext>
              </a:extLst>
            </p:cNvPr>
            <p:cNvSpPr txBox="1"/>
            <p:nvPr/>
          </p:nvSpPr>
          <p:spPr>
            <a:xfrm>
              <a:off x="81485" y="76685"/>
              <a:ext cx="6459274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2: </a:t>
              </a:r>
              <a:r>
                <a:rPr lang="en-GB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O of targets downregulated in PM-I vs PM-H </a:t>
              </a:r>
            </a:p>
            <a:p>
              <a:r>
                <a:rPr lang="en-GB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volved in Biological process</a:t>
              </a:r>
            </a:p>
            <a:p>
              <a:endParaRPr lang="en-GB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AC206075-D270-4FBF-B763-C67BD8BDF8F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160" t="27354" r="75722" b="47492"/>
            <a:stretch/>
          </p:blipFill>
          <p:spPr>
            <a:xfrm>
              <a:off x="8185212" y="4173421"/>
              <a:ext cx="3925302" cy="240244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99971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>
            <a:extLst>
              <a:ext uri="{FF2B5EF4-FFF2-40B4-BE49-F238E27FC236}">
                <a16:creationId xmlns:a16="http://schemas.microsoft.com/office/drawing/2014/main" id="{36CEC602-6069-44A0-B683-F3BA8DFBE0A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46588" y="0"/>
            <a:ext cx="3297237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2F98EE15-2B83-4ED3-BA84-CF5FDAB3262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60" t="27354" r="75722" b="47492"/>
          <a:stretch/>
        </p:blipFill>
        <p:spPr>
          <a:xfrm>
            <a:off x="8185212" y="4173421"/>
            <a:ext cx="3925302" cy="240244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9EDE107-53CE-4CC3-AB66-E33B379FF3FC}"/>
              </a:ext>
            </a:extLst>
          </p:cNvPr>
          <p:cNvSpPr txBox="1"/>
          <p:nvPr/>
        </p:nvSpPr>
        <p:spPr>
          <a:xfrm>
            <a:off x="239697" y="140160"/>
            <a:ext cx="6097554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: </a:t>
            </a:r>
            <a:r>
              <a:rPr lang="en-GB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 of targets </a:t>
            </a:r>
          </a:p>
          <a:p>
            <a:r>
              <a:rPr lang="en-GB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wnregulated in PM-I vs PM-H </a:t>
            </a:r>
          </a:p>
          <a:p>
            <a:r>
              <a:rPr lang="en-GB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olved in Cellular process</a:t>
            </a:r>
          </a:p>
        </p:txBody>
      </p:sp>
    </p:spTree>
    <p:extLst>
      <p:ext uri="{BB962C8B-B14F-4D97-AF65-F5344CB8AC3E}">
        <p14:creationId xmlns:p14="http://schemas.microsoft.com/office/powerpoint/2010/main" val="27503727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>
            <a:extLst>
              <a:ext uri="{FF2B5EF4-FFF2-40B4-BE49-F238E27FC236}">
                <a16:creationId xmlns:a16="http://schemas.microsoft.com/office/drawing/2014/main" id="{9348E849-5DEC-4344-AC44-2A0520AE6CA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19413" y="328613"/>
            <a:ext cx="6353175" cy="62007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EC29CFF-148B-480B-A952-E93CE1D70640}"/>
              </a:ext>
            </a:extLst>
          </p:cNvPr>
          <p:cNvSpPr txBox="1"/>
          <p:nvPr/>
        </p:nvSpPr>
        <p:spPr>
          <a:xfrm>
            <a:off x="139959" y="0"/>
            <a:ext cx="1048760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: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 of targets upregulated in PM-I vs PM-H involved in molecular process</a:t>
            </a:r>
          </a:p>
          <a:p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FEB58219-2D46-43CD-A460-14E91E17012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60" t="27354" r="75722" b="47492"/>
          <a:stretch/>
        </p:blipFill>
        <p:spPr>
          <a:xfrm>
            <a:off x="0" y="4210743"/>
            <a:ext cx="3925302" cy="24024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8655004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F1E2053-B7F2-48CA-8170-7ADEEC90E960}"/>
              </a:ext>
            </a:extLst>
          </p:cNvPr>
          <p:cNvSpPr txBox="1"/>
          <p:nvPr/>
        </p:nvSpPr>
        <p:spPr>
          <a:xfrm>
            <a:off x="239697" y="328612"/>
            <a:ext cx="36910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PS3-I vs PS3-H targets downregulated</a:t>
            </a:r>
          </a:p>
        </p:txBody>
      </p:sp>
      <p:pic>
        <p:nvPicPr>
          <p:cNvPr id="4098" name="Picture 2">
            <a:extLst>
              <a:ext uri="{FF2B5EF4-FFF2-40B4-BE49-F238E27FC236}">
                <a16:creationId xmlns:a16="http://schemas.microsoft.com/office/drawing/2014/main" id="{0339C573-6DF0-410F-AE73-F13606D0CC0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1788" y="0"/>
            <a:ext cx="11528425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58B564D-C360-44ED-8335-E9DB11F05882}"/>
              </a:ext>
            </a:extLst>
          </p:cNvPr>
          <p:cNvSpPr txBox="1"/>
          <p:nvPr/>
        </p:nvSpPr>
        <p:spPr>
          <a:xfrm>
            <a:off x="128138" y="97779"/>
            <a:ext cx="645927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: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 of targets downregulated in PS3-I vs PS3-H </a:t>
            </a:r>
          </a:p>
          <a:p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olved in Biological process</a:t>
            </a:r>
          </a:p>
          <a:p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01867DDE-0566-41E9-8246-58F38F7A807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60" t="27354" r="75722" b="47492"/>
          <a:stretch/>
        </p:blipFill>
        <p:spPr>
          <a:xfrm>
            <a:off x="8027002" y="4360033"/>
            <a:ext cx="3925302" cy="24024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626814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>
            <a:extLst>
              <a:ext uri="{FF2B5EF4-FFF2-40B4-BE49-F238E27FC236}">
                <a16:creationId xmlns:a16="http://schemas.microsoft.com/office/drawing/2014/main" id="{84BED783-B806-4F2C-B6AF-DD46FD7B814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54525" y="0"/>
            <a:ext cx="3281363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71E24558-87DE-487A-B5F8-D0FBD45F0C6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60" t="27354" r="75722" b="47492"/>
          <a:stretch/>
        </p:blipFill>
        <p:spPr>
          <a:xfrm>
            <a:off x="8259706" y="4285388"/>
            <a:ext cx="3925302" cy="240244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FB7CCB8-9A73-4AB7-AB61-1C4B152ACECE}"/>
              </a:ext>
            </a:extLst>
          </p:cNvPr>
          <p:cNvSpPr txBox="1"/>
          <p:nvPr/>
        </p:nvSpPr>
        <p:spPr>
          <a:xfrm>
            <a:off x="0" y="0"/>
            <a:ext cx="645927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6: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 of targets downregulated </a:t>
            </a:r>
          </a:p>
          <a:p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PS3-I vs PS3-H involved in Cellular process</a:t>
            </a:r>
          </a:p>
          <a:p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525484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>
            <a:extLst>
              <a:ext uri="{FF2B5EF4-FFF2-40B4-BE49-F238E27FC236}">
                <a16:creationId xmlns:a16="http://schemas.microsoft.com/office/drawing/2014/main" id="{01516EA9-C6AD-48CE-B4AB-007056C4D3C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74050" y="513278"/>
            <a:ext cx="4829175" cy="60483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D48C4A5-6679-4FF7-9094-C7ABD44101FD}"/>
              </a:ext>
            </a:extLst>
          </p:cNvPr>
          <p:cNvSpPr txBox="1"/>
          <p:nvPr/>
        </p:nvSpPr>
        <p:spPr>
          <a:xfrm>
            <a:off x="531240" y="53751"/>
            <a:ext cx="1175717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7: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 of targets upregulated in PS3-I vs PS3-H involved in molecular function</a:t>
            </a:r>
          </a:p>
          <a:p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FE35B26-8A37-40FD-89DC-6F0AE15EB6C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60" t="27354" r="75722" b="47492"/>
          <a:stretch/>
        </p:blipFill>
        <p:spPr>
          <a:xfrm>
            <a:off x="8259706" y="4285388"/>
            <a:ext cx="3925302" cy="24024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7994900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>
            <a:extLst>
              <a:ext uri="{FF2B5EF4-FFF2-40B4-BE49-F238E27FC236}">
                <a16:creationId xmlns:a16="http://schemas.microsoft.com/office/drawing/2014/main" id="{6C1E763C-FB7B-4014-929A-B252CF293F7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9596" y="-7253"/>
            <a:ext cx="11540617" cy="68652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70162AA3-2F1A-423E-8F50-69BB29C31C1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60" t="27354" r="75722" b="47492"/>
          <a:stretch/>
        </p:blipFill>
        <p:spPr>
          <a:xfrm>
            <a:off x="8259706" y="4285388"/>
            <a:ext cx="3925302" cy="240244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2F20E52-4427-4F3F-8A16-17DC6C20577C}"/>
              </a:ext>
            </a:extLst>
          </p:cNvPr>
          <p:cNvSpPr txBox="1"/>
          <p:nvPr/>
        </p:nvSpPr>
        <p:spPr>
          <a:xfrm>
            <a:off x="115229" y="170170"/>
            <a:ext cx="1175717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8: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 of targets downregulated in VC vs PM-H </a:t>
            </a:r>
          </a:p>
          <a:p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volved in biological process</a:t>
            </a:r>
          </a:p>
          <a:p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807457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276</Words>
  <Application>Microsoft Office PowerPoint</Application>
  <PresentationFormat>Widescreen</PresentationFormat>
  <Paragraphs>27</Paragraphs>
  <Slides>1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20" baseType="lpstr">
      <vt:lpstr>Arial</vt:lpstr>
      <vt:lpstr>Calibri</vt:lpstr>
      <vt:lpstr>Calibri Light</vt:lpstr>
      <vt:lpstr>Times New Roman</vt:lpstr>
      <vt:lpstr>Office Theme</vt:lpstr>
      <vt:lpstr>Worksheet</vt:lpstr>
      <vt:lpstr>Supplementary Figures</vt:lpstr>
      <vt:lpstr>Supplementary Figure 1. Workflow for the Illumina (HiSeq 2500 ) next generation sequencing data analysis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 </dc:creator>
  <cp:lastModifiedBy>Basavaprabhu Patil</cp:lastModifiedBy>
  <cp:revision>10</cp:revision>
  <dcterms:created xsi:type="dcterms:W3CDTF">2020-07-21T05:15:09Z</dcterms:created>
  <dcterms:modified xsi:type="dcterms:W3CDTF">2024-05-21T04:47:52Z</dcterms:modified>
</cp:coreProperties>
</file>